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450" y="-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B9BE0-40FA-4238-9F0A-78535571200B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035DA-34B2-42B2-8B42-7D76E208FDA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00964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B9BE0-40FA-4238-9F0A-78535571200B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035DA-34B2-42B2-8B42-7D76E208FDA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428799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B9BE0-40FA-4238-9F0A-78535571200B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035DA-34B2-42B2-8B42-7D76E208FDA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0164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B9BE0-40FA-4238-9F0A-78535571200B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035DA-34B2-42B2-8B42-7D76E208FDA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15387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B9BE0-40FA-4238-9F0A-78535571200B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035DA-34B2-42B2-8B42-7D76E208FDA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73121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B9BE0-40FA-4238-9F0A-78535571200B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035DA-34B2-42B2-8B42-7D76E208FDA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66582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B9BE0-40FA-4238-9F0A-78535571200B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035DA-34B2-42B2-8B42-7D76E208FDA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67715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B9BE0-40FA-4238-9F0A-78535571200B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035DA-34B2-42B2-8B42-7D76E208FDA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62534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B9BE0-40FA-4238-9F0A-78535571200B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035DA-34B2-42B2-8B42-7D76E208FDA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76059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B9BE0-40FA-4238-9F0A-78535571200B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035DA-34B2-42B2-8B42-7D76E208FDA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73233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4B9BE0-40FA-4238-9F0A-78535571200B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7035DA-34B2-42B2-8B42-7D76E208FDA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77138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4B9BE0-40FA-4238-9F0A-78535571200B}" type="datetimeFigureOut">
              <a:rPr lang="en-AU" smtClean="0"/>
              <a:t>18/07/2019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7035DA-34B2-42B2-8B42-7D76E208FDA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24293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45840" y="404664"/>
            <a:ext cx="7772400" cy="1080120"/>
          </a:xfrm>
        </p:spPr>
        <p:txBody>
          <a:bodyPr>
            <a:noAutofit/>
          </a:bodyPr>
          <a:lstStyle/>
          <a:p>
            <a:pPr algn="just"/>
            <a:r>
              <a:rPr lang="en-AU" sz="1800" smtClean="0"/>
              <a:t>Fig</a:t>
            </a:r>
            <a:r>
              <a:rPr lang="en-AU" sz="1800" dirty="0" smtClean="0"/>
              <a:t>. S4</a:t>
            </a:r>
            <a:r>
              <a:rPr lang="en-AU" sz="1800" dirty="0" smtClean="0"/>
              <a:t>: Principal </a:t>
            </a:r>
            <a:r>
              <a:rPr lang="en-AU" sz="1800" dirty="0"/>
              <a:t>components (PC1 and PC2) analysis showing population structure in a </a:t>
            </a:r>
            <a:r>
              <a:rPr lang="en-AU" sz="1800" dirty="0" smtClean="0"/>
              <a:t>GWAS diversity </a:t>
            </a:r>
            <a:r>
              <a:rPr lang="en-AU" sz="1800" dirty="0"/>
              <a:t>panel of </a:t>
            </a:r>
            <a:r>
              <a:rPr lang="en-AU" sz="1800" dirty="0" smtClean="0"/>
              <a:t>368 </a:t>
            </a:r>
            <a:r>
              <a:rPr lang="en-AU" sz="1800" i="1" dirty="0" smtClean="0"/>
              <a:t>B. </a:t>
            </a:r>
            <a:r>
              <a:rPr lang="en-AU" sz="1800" i="1" dirty="0" err="1" smtClean="0"/>
              <a:t>napus</a:t>
            </a:r>
            <a:r>
              <a:rPr lang="en-AU" sz="1800" i="1" dirty="0" smtClean="0"/>
              <a:t> </a:t>
            </a:r>
            <a:r>
              <a:rPr lang="en-AU" sz="1800" dirty="0" smtClean="0"/>
              <a:t>accessions</a:t>
            </a:r>
            <a:r>
              <a:rPr lang="en-AU" sz="1800" dirty="0"/>
              <a:t>. </a:t>
            </a:r>
            <a:r>
              <a:rPr lang="en-AU" sz="1800" dirty="0" smtClean="0"/>
              <a:t>Three major clusters </a:t>
            </a:r>
            <a:r>
              <a:rPr lang="en-AU" sz="1800" dirty="0"/>
              <a:t>designated as </a:t>
            </a:r>
            <a:r>
              <a:rPr lang="en-AU" sz="1800" dirty="0" smtClean="0"/>
              <a:t>I, II, and III, consistent </a:t>
            </a:r>
            <a:r>
              <a:rPr lang="en-AU" sz="1800" dirty="0"/>
              <a:t>with the cluster analysis (Supplemental Figure </a:t>
            </a:r>
            <a:r>
              <a:rPr lang="en-AU" sz="1800" dirty="0" smtClean="0"/>
              <a:t>2). </a:t>
            </a:r>
            <a:endParaRPr lang="en-AU" sz="18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5539" y="1536002"/>
            <a:ext cx="4944808" cy="494480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701727" y="6191726"/>
            <a:ext cx="6767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38.1%)</a:t>
            </a:r>
            <a:endParaRPr lang="en-AU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1916139" y="3492574"/>
            <a:ext cx="6767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11.9%)</a:t>
            </a:r>
            <a:endParaRPr lang="en-AU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Oval 2"/>
          <p:cNvSpPr/>
          <p:nvPr/>
        </p:nvSpPr>
        <p:spPr>
          <a:xfrm>
            <a:off x="3059832" y="4149080"/>
            <a:ext cx="2232248" cy="1872208"/>
          </a:xfrm>
          <a:prstGeom prst="ellipse">
            <a:avLst/>
          </a:prstGeom>
          <a:noFill/>
          <a:ln>
            <a:solidFill>
              <a:schemeClr val="accent3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7" name="Oval 6"/>
          <p:cNvSpPr/>
          <p:nvPr/>
        </p:nvSpPr>
        <p:spPr>
          <a:xfrm>
            <a:off x="2699792" y="2060848"/>
            <a:ext cx="2232248" cy="1944216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8" name="Oval 7"/>
          <p:cNvSpPr/>
          <p:nvPr/>
        </p:nvSpPr>
        <p:spPr>
          <a:xfrm>
            <a:off x="4860032" y="2780928"/>
            <a:ext cx="1800200" cy="1944216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252467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55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Fig. S4: Principal components (PC1 and PC2) analysis showing population structure in a GWAS diversity panel of 368 B. napus accessions. Three major clusters designated as I, II, and III, consistent with the cluster analysis (Supplemental Figure 2). </vt:lpstr>
    </vt:vector>
  </TitlesOfParts>
  <Company>NSW Governmen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luster analysis and population structure</dc:title>
  <dc:creator>NSW Government User</dc:creator>
  <cp:lastModifiedBy>NSW Government User</cp:lastModifiedBy>
  <cp:revision>7</cp:revision>
  <dcterms:created xsi:type="dcterms:W3CDTF">2018-08-28T10:10:08Z</dcterms:created>
  <dcterms:modified xsi:type="dcterms:W3CDTF">2019-07-18T00:33:49Z</dcterms:modified>
</cp:coreProperties>
</file>